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C4FB26-AF9E-4333-8C6D-48BAECC601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A532F0-17B7-473F-B789-667F40AF08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145A6-249C-49DA-A7BC-EFD81F39DA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73B210-A3F1-45FF-A4F0-6D18EA0ADE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BCEAED-9015-447A-A43C-68A7751756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FF6B2-4AC9-49A1-931F-597747FE96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11FF7-4A30-46CB-951D-184A26B85B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8DF9EB-3CA2-4995-9C1E-2EA8AC8028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E7178-DD1E-4D3C-99F1-3270D884FD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C3C70-4747-4776-B8B7-228470F111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462041-6180-4C43-AF53-E98BCC68CD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0E9861-0091-46E6-85C4-06BD20FBC5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2448F1-CC27-49F8-A938-278EA23942A3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38360" y="930240"/>
            <a:ext cx="262836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PE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a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o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A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X_tropicalis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727200" y="2787480"/>
            <a:ext cx="262836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PE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a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o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C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C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X_tropicalis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726480" y="4613400"/>
            <a:ext cx="261756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PE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a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o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CC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AC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X_tropicalis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604400" y="923760"/>
            <a:ext cx="263412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PE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a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o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AC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X_tropicalis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CCA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4646160" y="2787480"/>
            <a:ext cx="267696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PE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a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-----------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o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CCAC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4638960" y="4594320"/>
            <a:ext cx="262836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PE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a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T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o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T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C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r>
              <a:rPr b="1" lang="de-DE" sz="1200" spc="-1" strike="noStrike">
                <a:solidFill>
                  <a:srgbClr val="b2b2b2"/>
                </a:solidFill>
                <a:latin typeface="Arial"/>
              </a:rPr>
              <a:t>C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09T07:19:54Z</dcterms:created>
  <dc:creator>suckow</dc:creator>
  <dc:description/>
  <dc:language>en-US</dc:language>
  <cp:lastModifiedBy>winter</cp:lastModifiedBy>
  <dcterms:modified xsi:type="dcterms:W3CDTF">2007-07-10T08:31:09Z</dcterms:modified>
  <cp:revision>3</cp:revision>
  <dc:subject/>
  <dc:title>PowerPoint Presentation</dc:title>
</cp:coreProperties>
</file>